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71"/>
  </p:normalViewPr>
  <p:slideViewPr>
    <p:cSldViewPr snapToGrid="0" snapToObjects="1">
      <p:cViewPr>
        <p:scale>
          <a:sx n="90" d="100"/>
          <a:sy n="90" d="100"/>
        </p:scale>
        <p:origin x="-370" y="1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AAD312-04D1-6C4B-B59C-25FDE671D12B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384BE8-064F-204C-8607-621E52C3AFD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52852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CN" dirty="0"/>
              <a:t>naïve</a:t>
            </a:r>
            <a:r>
              <a:rPr kumimoji="1" lang="zh-CN" altLang="en-US" dirty="0"/>
              <a:t> </a:t>
            </a:r>
            <a:r>
              <a:rPr kumimoji="1" lang="en-US" altLang="zh-CN" dirty="0"/>
              <a:t>B</a:t>
            </a:r>
            <a:r>
              <a:rPr kumimoji="1" lang="zh-CN" altLang="en-US" dirty="0"/>
              <a:t>纯化率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9795A7-4841-104D-BC6F-6FDC4A3EBC59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3541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43D3AE4-3511-6B45-961A-AC91B9BE28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06969943-3CFA-6945-8C02-E17A64E3DC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2D1656E-9A7F-A545-AF1E-A32DA3A0A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001B969-EDD3-024F-9210-FA6A25710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0607B44-0222-234A-AF07-A170FC6A0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7161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5D21698-9EDA-6345-93EA-78C4005E5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127BED5A-E050-9147-86EB-CA1B1892D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17AE1925-8588-FF4E-912E-4CD22EDF0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3E21B74-CA44-0B40-B609-53168B7FD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759D2DC6-88A4-3F45-9903-B3D4BE7E3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4272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B6300FB3-CD1D-9A4C-A389-1E0C029868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7423A73F-AD89-E948-8F82-C42EC4F068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C95520A3-155C-5445-9364-C755335FF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DE0494E-9EA5-FA4D-AFFC-92CBFE046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7C6D145C-9F21-1C4A-8348-8670F3359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3858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33B145-B9C9-3E4C-8EF0-D180B32D9D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E5EBA081-40CE-2146-A1D1-FFB95C6866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104BEC22-E389-3A47-B691-AA15F21E4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2324957-CD1F-0A4C-B945-0B44648C0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DC1E0C82-3C0D-D749-B5D5-8093387A4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2595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9FC3A7A-ADD5-F744-8414-DB87932DE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51C76D0A-8A2E-F54E-8D97-CD268184E4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5C42EF9-2446-CC4A-813A-5FC41E6E9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6B187D8-D4EB-DB41-BB04-1A68C6A7D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593D9AF1-9E59-9244-80C9-BF795120D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7298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FCAC686-1C8E-B741-8BF9-0F4285034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E6A29820-F3DB-D54E-A51D-D967D3B449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37C18F71-DFD4-5148-8644-29233E1A02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48272514-8AA3-FC4C-9FA4-9DEF51016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324D4F33-1ED1-914F-B54C-1F181440D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CBC2177E-8F91-3F40-9D9A-423CE8E5D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0152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B82A509-6FA1-CD45-B48A-5145E8BA5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660BFE34-B727-3546-B938-09550F33B1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3067BFA5-A521-6B4A-8CEF-A50B8757A4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26D03CEE-0AB3-5B46-B4B0-F97372E062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D58A9304-6401-AC42-BD6B-DB7D727842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2136E9F1-EB6A-CB49-A392-6452D27E1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2AFD5460-3ACB-DE45-A287-D1D89E869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194C1C4E-8AF9-AE47-BF3E-9A8098AF9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8404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A73680AC-951C-5D4E-90D9-5B54D34C7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AEF10067-3406-014D-B788-A86E6BB08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104C3348-10C4-A84F-8A9F-591663F59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19B9A33E-63AA-FF42-ACBA-F3C12E001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5174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7577C144-3755-1140-8FBD-31D135E7F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0223F47D-B743-F844-ACE8-2784FA38B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205B3E7B-4605-5548-AA53-C9F686815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45983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1CB10F6-34DC-9549-8EFE-683A57157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8DED104-02F7-1D48-878B-915AF796AE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58A60A95-18C6-D948-BEAC-DF7751244B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E3C00479-A0F0-324F-9253-F8B2CECB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61873C02-784F-344F-97BE-C2423E675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B55A389C-2A57-7242-8E85-145BDC500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1814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4CCCA4C-1694-1B4E-96AA-58AF159E2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CACF9A03-32E2-C24D-81FE-A38DDE2BA0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13D56D4B-0D46-8545-8EF5-1E580C5221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85A64DB9-6156-A94F-A8E1-0A15FD563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C589F5BB-6FEC-E44A-BD04-73DB1A25E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0096EED0-BB3B-F84E-903E-FC15DF62C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1673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055FF784-2896-284B-85D2-891CD8E71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D579DF25-F64B-1E40-8441-648505F70B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D5BEF15-5D85-2E45-9E6F-5DB5A64547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CB3A9-B45A-BE4F-ADA0-FF0D8B3E1D27}" type="datetimeFigureOut">
              <a:rPr kumimoji="1" lang="zh-CN" altLang="en-US" smtClean="0"/>
              <a:t>2022/4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B575D9E3-6421-9847-817C-18DD7A549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11DD268-95ED-8B4F-BCC7-2A0FD4E4FF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59661-B441-5D4D-ADD9-9679DC18839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2105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="" xmlns:a16="http://schemas.microsoft.com/office/drawing/2014/main" id="{7E94FD04-413B-524E-9A4D-B55F6AB30F5E}"/>
              </a:ext>
            </a:extLst>
          </p:cNvPr>
          <p:cNvGrpSpPr/>
          <p:nvPr/>
        </p:nvGrpSpPr>
        <p:grpSpPr>
          <a:xfrm>
            <a:off x="7674880" y="3399734"/>
            <a:ext cx="883594" cy="724486"/>
            <a:chOff x="443545" y="1749193"/>
            <a:chExt cx="883594" cy="724486"/>
          </a:xfrm>
        </p:grpSpPr>
        <p:sp>
          <p:nvSpPr>
            <p:cNvPr id="11" name="文本框 10">
              <a:extLst>
                <a:ext uri="{FF2B5EF4-FFF2-40B4-BE49-F238E27FC236}">
                  <a16:creationId xmlns="" xmlns:a16="http://schemas.microsoft.com/office/drawing/2014/main" id="{6672DF46-80C0-3C48-9E5A-F5EEE2F0DE28}"/>
                </a:ext>
              </a:extLst>
            </p:cNvPr>
            <p:cNvSpPr txBox="1"/>
            <p:nvPr/>
          </p:nvSpPr>
          <p:spPr>
            <a:xfrm>
              <a:off x="815460" y="2227458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="" xmlns:a16="http://schemas.microsoft.com/office/drawing/2014/main" id="{83810A00-EC26-2D4A-8C39-BFDF682174C7}"/>
                </a:ext>
              </a:extLst>
            </p:cNvPr>
            <p:cNvSpPr txBox="1"/>
            <p:nvPr/>
          </p:nvSpPr>
          <p:spPr>
            <a:xfrm rot="16200000">
              <a:off x="374937" y="1817801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g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箭头连接符 831">
              <a:extLst>
                <a:ext uri="{FF2B5EF4-FFF2-40B4-BE49-F238E27FC236}">
                  <a16:creationId xmlns="" xmlns:a16="http://schemas.microsoft.com/office/drawing/2014/main" id="{95CFC85B-2F5D-DD4D-A5E4-D7B04EB41325}"/>
                </a:ext>
              </a:extLst>
            </p:cNvPr>
            <p:cNvCxnSpPr>
              <a:cxnSpLocks/>
            </p:cNvCxnSpPr>
            <p:nvPr/>
          </p:nvCxnSpPr>
          <p:spPr>
            <a:xfrm>
              <a:off x="583557" y="2349342"/>
              <a:ext cx="29063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4" name="直接箭头连接符 832">
              <a:extLst>
                <a:ext uri="{FF2B5EF4-FFF2-40B4-BE49-F238E27FC236}">
                  <a16:creationId xmlns="" xmlns:a16="http://schemas.microsoft.com/office/drawing/2014/main" id="{735DE80D-9958-4544-A1DA-BEE654FEB92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83383" y="2064160"/>
              <a:ext cx="0" cy="28550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pic>
        <p:nvPicPr>
          <p:cNvPr id="29" name="图片 28">
            <a:extLst>
              <a:ext uri="{FF2B5EF4-FFF2-40B4-BE49-F238E27FC236}">
                <a16:creationId xmlns="" xmlns:a16="http://schemas.microsoft.com/office/drawing/2014/main" id="{6DE5E35E-A4E3-7941-BC74-EA067DE5CB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8264" y="2696880"/>
            <a:ext cx="1118203" cy="1118203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="" xmlns:a16="http://schemas.microsoft.com/office/drawing/2014/main" id="{8C23E773-D006-D74C-98DB-D11FDA6C39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98117" y="2696879"/>
            <a:ext cx="1118204" cy="111820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="" xmlns:a16="http://schemas.microsoft.com/office/drawing/2014/main" id="{A356DCB3-0877-644F-9244-46453D409F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47971" y="2699083"/>
            <a:ext cx="1116000" cy="1116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="" xmlns:a16="http://schemas.microsoft.com/office/drawing/2014/main" id="{F7304DCD-62EA-434E-B186-B9B8E128B39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95621" y="2699083"/>
            <a:ext cx="1116000" cy="1116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="" xmlns:a16="http://schemas.microsoft.com/office/drawing/2014/main" id="{6D242DD1-10A5-0A45-9F7F-BA84274C2E1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48264" y="1536377"/>
            <a:ext cx="1116000" cy="11160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="" xmlns:a16="http://schemas.microsoft.com/office/drawing/2014/main" id="{8D110A0E-4E34-9547-A7D4-17D0F614582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97383" y="1536377"/>
            <a:ext cx="1116000" cy="1116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="" xmlns:a16="http://schemas.microsoft.com/office/drawing/2014/main" id="{FB5937A4-14A6-304B-B32C-E3666AAFA0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46502" y="1536377"/>
            <a:ext cx="1116000" cy="111600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="" xmlns:a16="http://schemas.microsoft.com/office/drawing/2014/main" id="{ED01D064-FB84-2E4F-BB98-0D76CEF7F14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95621" y="1536377"/>
            <a:ext cx="1116000" cy="1116000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="" xmlns:a16="http://schemas.microsoft.com/office/drawing/2014/main" id="{063E41A6-2681-2E49-B43D-88231197ACC8}"/>
              </a:ext>
            </a:extLst>
          </p:cNvPr>
          <p:cNvSpPr txBox="1"/>
          <p:nvPr/>
        </p:nvSpPr>
        <p:spPr>
          <a:xfrm>
            <a:off x="3501979" y="3036747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kumimoji="1"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="" xmlns:a16="http://schemas.microsoft.com/office/drawing/2014/main" id="{0BC7CCB8-291D-5745-ADA1-CA2AFAEACCCC}"/>
              </a:ext>
            </a:extLst>
          </p:cNvPr>
          <p:cNvSpPr txBox="1"/>
          <p:nvPr/>
        </p:nvSpPr>
        <p:spPr>
          <a:xfrm>
            <a:off x="3602968" y="1954332"/>
            <a:ext cx="269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="" xmlns:a16="http://schemas.microsoft.com/office/drawing/2014/main" id="{41FDA830-DE29-3541-994E-9611CA604E84}"/>
              </a:ext>
            </a:extLst>
          </p:cNvPr>
          <p:cNvGrpSpPr/>
          <p:nvPr/>
        </p:nvGrpSpPr>
        <p:grpSpPr>
          <a:xfrm>
            <a:off x="3637529" y="3308405"/>
            <a:ext cx="796127" cy="815815"/>
            <a:chOff x="460479" y="1657864"/>
            <a:chExt cx="796127" cy="815815"/>
          </a:xfrm>
        </p:grpSpPr>
        <p:sp>
          <p:nvSpPr>
            <p:cNvPr id="40" name="文本框 39">
              <a:extLst>
                <a:ext uri="{FF2B5EF4-FFF2-40B4-BE49-F238E27FC236}">
                  <a16:creationId xmlns="" xmlns:a16="http://schemas.microsoft.com/office/drawing/2014/main" id="{0CFB2959-CF4F-E44D-8975-57207CCCC7E1}"/>
                </a:ext>
              </a:extLst>
            </p:cNvPr>
            <p:cNvSpPr txBox="1"/>
            <p:nvPr/>
          </p:nvSpPr>
          <p:spPr>
            <a:xfrm>
              <a:off x="815460" y="222745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="" xmlns:a16="http://schemas.microsoft.com/office/drawing/2014/main" id="{2D951C38-6A1E-5D41-BCE2-CA9A20EFF452}"/>
                </a:ext>
              </a:extLst>
            </p:cNvPr>
            <p:cNvSpPr txBox="1"/>
            <p:nvPr/>
          </p:nvSpPr>
          <p:spPr>
            <a:xfrm rot="16200000">
              <a:off x="359811" y="1758532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箭头连接符 831">
              <a:extLst>
                <a:ext uri="{FF2B5EF4-FFF2-40B4-BE49-F238E27FC236}">
                  <a16:creationId xmlns="" xmlns:a16="http://schemas.microsoft.com/office/drawing/2014/main" id="{1792DD28-17C6-6A43-9630-6E3730F39C5F}"/>
                </a:ext>
              </a:extLst>
            </p:cNvPr>
            <p:cNvCxnSpPr>
              <a:cxnSpLocks/>
            </p:cNvCxnSpPr>
            <p:nvPr/>
          </p:nvCxnSpPr>
          <p:spPr>
            <a:xfrm>
              <a:off x="583557" y="2349342"/>
              <a:ext cx="29063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43" name="直接箭头连接符 832">
              <a:extLst>
                <a:ext uri="{FF2B5EF4-FFF2-40B4-BE49-F238E27FC236}">
                  <a16:creationId xmlns="" xmlns:a16="http://schemas.microsoft.com/office/drawing/2014/main" id="{FAC05505-2895-384A-8D4B-D84C6AC0148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83383" y="2064160"/>
              <a:ext cx="0" cy="28550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grpSp>
        <p:nvGrpSpPr>
          <p:cNvPr id="44" name="组合 43">
            <a:extLst>
              <a:ext uri="{FF2B5EF4-FFF2-40B4-BE49-F238E27FC236}">
                <a16:creationId xmlns="" xmlns:a16="http://schemas.microsoft.com/office/drawing/2014/main" id="{79688A72-16F8-6E4E-8711-4327B90281E8}"/>
              </a:ext>
            </a:extLst>
          </p:cNvPr>
          <p:cNvGrpSpPr/>
          <p:nvPr/>
        </p:nvGrpSpPr>
        <p:grpSpPr>
          <a:xfrm>
            <a:off x="4969202" y="3193999"/>
            <a:ext cx="813060" cy="930221"/>
            <a:chOff x="443546" y="1543458"/>
            <a:chExt cx="813060" cy="930221"/>
          </a:xfrm>
        </p:grpSpPr>
        <p:sp>
          <p:nvSpPr>
            <p:cNvPr id="45" name="文本框 44">
              <a:extLst>
                <a:ext uri="{FF2B5EF4-FFF2-40B4-BE49-F238E27FC236}">
                  <a16:creationId xmlns="" xmlns:a16="http://schemas.microsoft.com/office/drawing/2014/main" id="{0CCC433C-F7F7-5F4D-8E93-A5BF893E6E9B}"/>
                </a:ext>
              </a:extLst>
            </p:cNvPr>
            <p:cNvSpPr txBox="1"/>
            <p:nvPr/>
          </p:nvSpPr>
          <p:spPr>
            <a:xfrm>
              <a:off x="815460" y="222745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="" xmlns:a16="http://schemas.microsoft.com/office/drawing/2014/main" id="{9FDE0F5B-8D58-9140-B3BB-EE333ABEBA05}"/>
                </a:ext>
              </a:extLst>
            </p:cNvPr>
            <p:cNvSpPr txBox="1"/>
            <p:nvPr/>
          </p:nvSpPr>
          <p:spPr>
            <a:xfrm rot="16200000">
              <a:off x="264330" y="1722674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  <a:r>
                <a:rPr kumimoji="1" lang="en-US" altLang="zh-CN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箭头连接符 831">
              <a:extLst>
                <a:ext uri="{FF2B5EF4-FFF2-40B4-BE49-F238E27FC236}">
                  <a16:creationId xmlns="" xmlns:a16="http://schemas.microsoft.com/office/drawing/2014/main" id="{CC895EA8-F7B3-0C4A-BEF6-6AAC9E2935B2}"/>
                </a:ext>
              </a:extLst>
            </p:cNvPr>
            <p:cNvCxnSpPr>
              <a:cxnSpLocks/>
            </p:cNvCxnSpPr>
            <p:nvPr/>
          </p:nvCxnSpPr>
          <p:spPr>
            <a:xfrm>
              <a:off x="583557" y="2349342"/>
              <a:ext cx="29063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48" name="直接箭头连接符 832">
              <a:extLst>
                <a:ext uri="{FF2B5EF4-FFF2-40B4-BE49-F238E27FC236}">
                  <a16:creationId xmlns="" xmlns:a16="http://schemas.microsoft.com/office/drawing/2014/main" id="{E4425D26-E87F-5F4A-90C9-D51D4154376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83383" y="2064160"/>
              <a:ext cx="0" cy="28550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grpSp>
        <p:nvGrpSpPr>
          <p:cNvPr id="49" name="组合 48">
            <a:extLst>
              <a:ext uri="{FF2B5EF4-FFF2-40B4-BE49-F238E27FC236}">
                <a16:creationId xmlns="" xmlns:a16="http://schemas.microsoft.com/office/drawing/2014/main" id="{CB5E55AE-DDB2-EB49-ADB4-D0C5D129287A}"/>
              </a:ext>
            </a:extLst>
          </p:cNvPr>
          <p:cNvGrpSpPr/>
          <p:nvPr/>
        </p:nvGrpSpPr>
        <p:grpSpPr>
          <a:xfrm>
            <a:off x="6351676" y="3282821"/>
            <a:ext cx="804593" cy="841399"/>
            <a:chOff x="452013" y="1632280"/>
            <a:chExt cx="804593" cy="841399"/>
          </a:xfrm>
        </p:grpSpPr>
        <p:sp>
          <p:nvSpPr>
            <p:cNvPr id="50" name="文本框 49">
              <a:extLst>
                <a:ext uri="{FF2B5EF4-FFF2-40B4-BE49-F238E27FC236}">
                  <a16:creationId xmlns="" xmlns:a16="http://schemas.microsoft.com/office/drawing/2014/main" id="{F299B9D5-11E2-4543-9D20-29995B19B793}"/>
                </a:ext>
              </a:extLst>
            </p:cNvPr>
            <p:cNvSpPr txBox="1"/>
            <p:nvPr/>
          </p:nvSpPr>
          <p:spPr>
            <a:xfrm>
              <a:off x="815460" y="222745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="" xmlns:a16="http://schemas.microsoft.com/office/drawing/2014/main" id="{81735DDF-E55F-EF40-866C-02F2A8C9A834}"/>
                </a:ext>
              </a:extLst>
            </p:cNvPr>
            <p:cNvSpPr txBox="1"/>
            <p:nvPr/>
          </p:nvSpPr>
          <p:spPr>
            <a:xfrm rot="16200000">
              <a:off x="319284" y="1765009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endParaRPr kumimoji="1" lang="zh-CN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接箭头连接符 831">
              <a:extLst>
                <a:ext uri="{FF2B5EF4-FFF2-40B4-BE49-F238E27FC236}">
                  <a16:creationId xmlns="" xmlns:a16="http://schemas.microsoft.com/office/drawing/2014/main" id="{12F6EE29-0127-1A46-8D2A-9DAE574F887D}"/>
                </a:ext>
              </a:extLst>
            </p:cNvPr>
            <p:cNvCxnSpPr>
              <a:cxnSpLocks/>
            </p:cNvCxnSpPr>
            <p:nvPr/>
          </p:nvCxnSpPr>
          <p:spPr>
            <a:xfrm>
              <a:off x="583557" y="2349342"/>
              <a:ext cx="29063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3" name="直接箭头连接符 832">
              <a:extLst>
                <a:ext uri="{FF2B5EF4-FFF2-40B4-BE49-F238E27FC236}">
                  <a16:creationId xmlns="" xmlns:a16="http://schemas.microsoft.com/office/drawing/2014/main" id="{7BE1E8F4-A225-C142-B1DC-C41C6DE8E53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83383" y="2064160"/>
              <a:ext cx="0" cy="28550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05FFCB20-1BDB-7E44-9AA0-6948CDC00CFB}"/>
              </a:ext>
            </a:extLst>
          </p:cNvPr>
          <p:cNvSpPr txBox="1"/>
          <p:nvPr/>
        </p:nvSpPr>
        <p:spPr>
          <a:xfrm>
            <a:off x="7889017" y="273125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5.8%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="" xmlns:a16="http://schemas.microsoft.com/office/drawing/2014/main" id="{281CAA52-14AD-9E4D-A61D-152E5954EF96}"/>
              </a:ext>
            </a:extLst>
          </p:cNvPr>
          <p:cNvSpPr txBox="1"/>
          <p:nvPr/>
        </p:nvSpPr>
        <p:spPr>
          <a:xfrm>
            <a:off x="7868573" y="154677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1.2%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36">
            <a:extLst>
              <a:ext uri="{FF2B5EF4-FFF2-40B4-BE49-F238E27FC236}">
                <a16:creationId xmlns="" xmlns:a16="http://schemas.microsoft.com/office/drawing/2014/main" id="{063E41A6-2681-2E49-B43D-88231197ACC8}"/>
              </a:ext>
            </a:extLst>
          </p:cNvPr>
          <p:cNvSpPr txBox="1"/>
          <p:nvPr/>
        </p:nvSpPr>
        <p:spPr>
          <a:xfrm>
            <a:off x="3824680" y="4476079"/>
            <a:ext cx="52935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. Purification of human naïve B cells. </a:t>
            </a:r>
            <a:r>
              <a:rPr kumimoji="1"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aïve B cells were purified from PBMC using </a:t>
            </a:r>
            <a:r>
              <a:rPr lang="en-US" altLang="ja-JP" sz="1000" dirty="0" err="1">
                <a:latin typeface="Arial" pitchFamily="34" charset="0"/>
                <a:cs typeface="Arial" pitchFamily="34" charset="0"/>
              </a:rPr>
              <a:t>MojoSort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 Human Naïve B Cell Isolation Kit (</a:t>
            </a:r>
            <a:r>
              <a:rPr lang="en-US" altLang="ja-JP" sz="1000" dirty="0" err="1">
                <a:latin typeface="Arial" pitchFamily="34" charset="0"/>
                <a:cs typeface="Arial" pitchFamily="34" charset="0"/>
              </a:rPr>
              <a:t>Biolegend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). </a:t>
            </a:r>
            <a:r>
              <a:rPr lang="en-US" altLang="ja-JP" sz="1000" dirty="0" err="1" smtClean="0">
                <a:latin typeface="Arial" pitchFamily="34" charset="0"/>
                <a:cs typeface="Arial" pitchFamily="34" charset="0"/>
              </a:rPr>
              <a:t>Biotinylated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anti-human </a:t>
            </a:r>
            <a:r>
              <a:rPr lang="en-US" altLang="ja-JP" sz="1000" dirty="0" err="1" smtClean="0">
                <a:latin typeface="Arial" pitchFamily="34" charset="0"/>
                <a:cs typeface="Arial" pitchFamily="34" charset="0"/>
              </a:rPr>
              <a:t>IgG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-conjugated 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beads 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were also added to 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remove </a:t>
            </a:r>
            <a:r>
              <a:rPr lang="en-US" altLang="ja-JP" sz="1000" dirty="0" err="1">
                <a:latin typeface="Arial" pitchFamily="34" charset="0"/>
                <a:cs typeface="Arial" pitchFamily="34" charset="0"/>
              </a:rPr>
              <a:t>IgG</a:t>
            </a:r>
            <a:r>
              <a:rPr lang="en-US" altLang="ja-JP" sz="10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cells. More than 90% of the purified B cells were CD27</a:t>
            </a:r>
            <a:r>
              <a:rPr lang="en-US" altLang="ja-JP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IgD</a:t>
            </a:r>
            <a:r>
              <a:rPr lang="en-US" altLang="ja-JP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.  </a:t>
            </a:r>
            <a:r>
              <a:rPr kumimoji="1"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5003069" y="1987416"/>
            <a:ext cx="2936790" cy="0"/>
            <a:chOff x="5003069" y="2114421"/>
            <a:chExt cx="2936790" cy="0"/>
          </a:xfrm>
        </p:grpSpPr>
        <p:cxnSp>
          <p:nvCxnSpPr>
            <p:cNvPr id="3" name="直線矢印コネクタ 2"/>
            <p:cNvCxnSpPr/>
            <p:nvPr/>
          </p:nvCxnSpPr>
          <p:spPr>
            <a:xfrm>
              <a:off x="5003069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/>
            <p:cNvCxnSpPr/>
            <p:nvPr/>
          </p:nvCxnSpPr>
          <p:spPr>
            <a:xfrm>
              <a:off x="6363464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/>
            <p:cNvCxnSpPr/>
            <p:nvPr/>
          </p:nvCxnSpPr>
          <p:spPr>
            <a:xfrm>
              <a:off x="7723859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グループ化 56"/>
          <p:cNvGrpSpPr/>
          <p:nvPr/>
        </p:nvGrpSpPr>
        <p:grpSpPr>
          <a:xfrm>
            <a:off x="5003069" y="3174548"/>
            <a:ext cx="2936790" cy="0"/>
            <a:chOff x="5003069" y="2114421"/>
            <a:chExt cx="2936790" cy="0"/>
          </a:xfrm>
        </p:grpSpPr>
        <p:cxnSp>
          <p:nvCxnSpPr>
            <p:cNvPr id="59" name="直線矢印コネクタ 58"/>
            <p:cNvCxnSpPr/>
            <p:nvPr/>
          </p:nvCxnSpPr>
          <p:spPr>
            <a:xfrm>
              <a:off x="5003069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矢印コネクタ 59"/>
            <p:cNvCxnSpPr/>
            <p:nvPr/>
          </p:nvCxnSpPr>
          <p:spPr>
            <a:xfrm>
              <a:off x="6363464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矢印コネクタ 60"/>
            <p:cNvCxnSpPr/>
            <p:nvPr/>
          </p:nvCxnSpPr>
          <p:spPr>
            <a:xfrm>
              <a:off x="7723859" y="2114421"/>
              <a:ext cx="216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42815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3</TotalTime>
  <Words>72</Words>
  <Application>Microsoft Office PowerPoint</Application>
  <PresentationFormat>ユーザー設定</PresentationFormat>
  <Paragraphs>15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主题​​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Wenjie</dc:creator>
  <cp:lastModifiedBy>安田百合</cp:lastModifiedBy>
  <cp:revision>9</cp:revision>
  <dcterms:created xsi:type="dcterms:W3CDTF">2022-04-23T09:55:45Z</dcterms:created>
  <dcterms:modified xsi:type="dcterms:W3CDTF">2022-04-27T12:56:53Z</dcterms:modified>
</cp:coreProperties>
</file>